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amura, Kosuke (NIH/NHLBI) [C]" initials="TK([" lastIdx="2" clrIdx="0">
    <p:extLst>
      <p:ext uri="{19B8F6BF-5375-455C-9EA6-DF929625EA0E}">
        <p15:presenceInfo xmlns:p15="http://schemas.microsoft.com/office/powerpoint/2012/main" userId="S::tamurak2@nih.gov::0cd80b30-67c9-4604-a2c6-16a7d1007b97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0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2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hl-share.nhlbi.nih.gov\tmb\Lab-Powell\Jackson%20Heart%20Study\Depression-Project\Manuscript\Figures\forest%20plot%20SN%20-%208-1-2019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92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Estimates of Depressive Symptoms Score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92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4.5854415970449348E-2"/>
          <c:y val="0.11180938745435939"/>
          <c:w val="0.91202038599345481"/>
          <c:h val="0.55845028903600114"/>
        </c:manualLayout>
      </c:layout>
      <c:scatterChart>
        <c:scatterStyle val="lineMarker"/>
        <c:varyColors val="0"/>
        <c:ser>
          <c:idx val="0"/>
          <c:order val="0"/>
          <c:tx>
            <c:strRef>
              <c:f>'[forest plot SN - 8-1-2019.xlsx]Neighborhood SC (2)'!$B$1</c:f>
              <c:strCache>
                <c:ptCount val="1"/>
                <c:pt idx="0">
                  <c:v>Age &lt; 55; Females 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plus"/>
            <c:size val="9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dPt>
            <c:idx val="0"/>
            <c:marker>
              <c:symbol val="plus"/>
              <c:size val="18"/>
              <c:spPr>
                <a:solidFill>
                  <a:schemeClr val="accent1"/>
                </a:solidFill>
                <a:ln w="9525">
                  <a:solidFill>
                    <a:schemeClr val="accent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C578-4694-BAED-F90E891C8736}"/>
              </c:ext>
            </c:extLst>
          </c:dPt>
          <c:dLbls>
            <c:dLbl>
              <c:idx val="0"/>
              <c:tx>
                <c:rich>
                  <a:bodyPr/>
                  <a:lstStyle/>
                  <a:p>
                    <a:r>
                      <a:rPr lang="it-IT" dirty="0"/>
                      <a:t>B = -1.16</a:t>
                    </a:r>
                    <a:r>
                      <a:rPr lang="it-IT" baseline="0" dirty="0"/>
                      <a:t> (95% CI -6.12, 3.80)</a:t>
                    </a:r>
                    <a:endParaRPr lang="it-IT" dirty="0"/>
                  </a:p>
                </c:rich>
              </c:tx>
              <c:dLblPos val="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C578-4694-BAED-F90E891C8736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t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Dir val="x"/>
            <c:errBarType val="both"/>
            <c:errValType val="cust"/>
            <c:noEndCap val="0"/>
            <c:plus>
              <c:numRef>
                <c:f>'[forest plot SN - 8-1-2019.xlsx]Neighborhood SC (2)'!$B$7</c:f>
                <c:numCache>
                  <c:formatCode>General</c:formatCode>
                  <c:ptCount val="1"/>
                  <c:pt idx="0">
                    <c:v>5</c:v>
                  </c:pt>
                </c:numCache>
              </c:numRef>
            </c:plus>
            <c:minus>
              <c:numRef>
                <c:f>'[forest plot SN - 8-1-2019.xlsx]Neighborhood SC (2)'!$B$7</c:f>
                <c:numCache>
                  <c:formatCode>General</c:formatCode>
                  <c:ptCount val="1"/>
                  <c:pt idx="0">
                    <c:v>5</c:v>
                  </c:pt>
                </c:numCache>
              </c:numRef>
            </c:minus>
            <c:spPr>
              <a:noFill/>
              <a:ln w="25400" cap="rnd" cmpd="sng" algn="ctr">
                <a:solidFill>
                  <a:schemeClr val="accent1"/>
                </a:solidFill>
                <a:prstDash val="solid"/>
                <a:round/>
                <a:headEnd type="oval" w="lg" len="lg"/>
                <a:tailEnd type="oval" w="lg" len="lg"/>
              </a:ln>
              <a:effectLst/>
            </c:spPr>
          </c:errBars>
          <c:xVal>
            <c:numRef>
              <c:f>'[forest plot SN - 8-1-2019.xlsx]Neighborhood SC (2)'!$B$2</c:f>
              <c:numCache>
                <c:formatCode>General</c:formatCode>
                <c:ptCount val="1"/>
                <c:pt idx="0">
                  <c:v>-1.1599999999999999</c:v>
                </c:pt>
              </c:numCache>
            </c:numRef>
          </c:xVal>
          <c:yVal>
            <c:numLit>
              <c:formatCode>General</c:formatCode>
              <c:ptCount val="1"/>
              <c:pt idx="0">
                <c:v>4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01-C578-4694-BAED-F90E891C8736}"/>
            </c:ext>
          </c:extLst>
        </c:ser>
        <c:ser>
          <c:idx val="1"/>
          <c:order val="1"/>
          <c:tx>
            <c:strRef>
              <c:f>'[forest plot SN - 8-1-2019.xlsx]Neighborhood SC (2)'!$C$1</c:f>
              <c:strCache>
                <c:ptCount val="1"/>
                <c:pt idx="0">
                  <c:v>Age ≥ 55; Females 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plus"/>
            <c:size val="18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dLbls>
            <c:dLbl>
              <c:idx val="0"/>
              <c:tx>
                <c:rich>
                  <a:bodyPr/>
                  <a:lstStyle/>
                  <a:p>
                    <a:r>
                      <a:rPr lang="it-IT" dirty="0"/>
                      <a:t>B = -1.97 (95% CI -6.71, 2.76)</a:t>
                    </a:r>
                  </a:p>
                </c:rich>
              </c:tx>
              <c:dLblPos val="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C578-4694-BAED-F90E891C8736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t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Dir val="x"/>
            <c:errBarType val="both"/>
            <c:errValType val="cust"/>
            <c:noEndCap val="0"/>
            <c:plus>
              <c:numRef>
                <c:f>'[forest plot SN - 8-1-2019.xlsx]Neighborhood SC (2)'!$C$7</c:f>
                <c:numCache>
                  <c:formatCode>General</c:formatCode>
                  <c:ptCount val="1"/>
                  <c:pt idx="0">
                    <c:v>4.74</c:v>
                  </c:pt>
                </c:numCache>
              </c:numRef>
            </c:plus>
            <c:minus>
              <c:numRef>
                <c:f>'[forest plot SN - 8-1-2019.xlsx]Neighborhood SC (2)'!$C$7</c:f>
                <c:numCache>
                  <c:formatCode>General</c:formatCode>
                  <c:ptCount val="1"/>
                  <c:pt idx="0">
                    <c:v>4.74</c:v>
                  </c:pt>
                </c:numCache>
              </c:numRef>
            </c:minus>
            <c:spPr>
              <a:noFill/>
              <a:ln w="25400" cap="rnd" cmpd="sng" algn="ctr">
                <a:solidFill>
                  <a:schemeClr val="accent2"/>
                </a:solidFill>
                <a:prstDash val="solid"/>
                <a:round/>
                <a:headEnd type="oval" w="lg" len="lg"/>
                <a:tailEnd type="oval" w="lg" len="lg"/>
              </a:ln>
              <a:effectLst/>
            </c:spPr>
          </c:errBars>
          <c:xVal>
            <c:numRef>
              <c:f>'[forest plot SN - 8-1-2019.xlsx]Neighborhood SC (2)'!$C$2</c:f>
              <c:numCache>
                <c:formatCode>General</c:formatCode>
                <c:ptCount val="1"/>
                <c:pt idx="0">
                  <c:v>-1.97</c:v>
                </c:pt>
              </c:numCache>
            </c:numRef>
          </c:xVal>
          <c:yVal>
            <c:numLit>
              <c:formatCode>General</c:formatCode>
              <c:ptCount val="1"/>
              <c:pt idx="0">
                <c:v>3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03-C578-4694-BAED-F90E891C8736}"/>
            </c:ext>
          </c:extLst>
        </c:ser>
        <c:ser>
          <c:idx val="2"/>
          <c:order val="2"/>
          <c:tx>
            <c:strRef>
              <c:f>'[forest plot SN - 8-1-2019.xlsx]Neighborhood SC (2)'!$D$1</c:f>
              <c:strCache>
                <c:ptCount val="1"/>
                <c:pt idx="0">
                  <c:v>Age &lt; 55; Males 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plus"/>
            <c:size val="18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dLbls>
            <c:dLbl>
              <c:idx val="0"/>
              <c:tx>
                <c:rich>
                  <a:bodyPr/>
                  <a:lstStyle/>
                  <a:p>
                    <a:r>
                      <a:rPr lang="it-IT" dirty="0"/>
                      <a:t>B</a:t>
                    </a:r>
                    <a:r>
                      <a:rPr lang="it-IT" baseline="0" dirty="0"/>
                      <a:t> = -4.30 (95% CI -9.41, 0.80)</a:t>
                    </a:r>
                  </a:p>
                </c:rich>
              </c:tx>
              <c:dLblPos val="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4-C578-4694-BAED-F90E891C8736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t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Dir val="x"/>
            <c:errBarType val="both"/>
            <c:errValType val="cust"/>
            <c:noEndCap val="0"/>
            <c:plus>
              <c:numRef>
                <c:f>'[forest plot SN - 8-1-2019.xlsx]Neighborhood SC (2)'!$D$7</c:f>
                <c:numCache>
                  <c:formatCode>General</c:formatCode>
                  <c:ptCount val="1"/>
                  <c:pt idx="0">
                    <c:v>5.14</c:v>
                  </c:pt>
                </c:numCache>
              </c:numRef>
            </c:plus>
            <c:minus>
              <c:numRef>
                <c:f>'[forest plot SN - 8-1-2019.xlsx]Neighborhood SC (2)'!$D$7</c:f>
                <c:numCache>
                  <c:formatCode>General</c:formatCode>
                  <c:ptCount val="1"/>
                  <c:pt idx="0">
                    <c:v>5.14</c:v>
                  </c:pt>
                </c:numCache>
              </c:numRef>
            </c:minus>
            <c:spPr>
              <a:noFill/>
              <a:ln w="25400" cap="rnd" cmpd="sng" algn="ctr">
                <a:solidFill>
                  <a:schemeClr val="accent3"/>
                </a:solidFill>
                <a:prstDash val="solid"/>
                <a:round/>
                <a:headEnd type="oval" w="lg" len="lg"/>
                <a:tailEnd type="oval" w="lg" len="lg"/>
              </a:ln>
              <a:effectLst/>
            </c:spPr>
          </c:errBars>
          <c:xVal>
            <c:numRef>
              <c:f>'[forest plot SN - 8-1-2019.xlsx]Neighborhood SC (2)'!$D$2</c:f>
              <c:numCache>
                <c:formatCode>General</c:formatCode>
                <c:ptCount val="1"/>
                <c:pt idx="0">
                  <c:v>-4.3</c:v>
                </c:pt>
              </c:numCache>
            </c:numRef>
          </c:xVal>
          <c:yVal>
            <c:numLit>
              <c:formatCode>General</c:formatCode>
              <c:ptCount val="1"/>
              <c:pt idx="0">
                <c:v>2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05-C578-4694-BAED-F90E891C8736}"/>
            </c:ext>
          </c:extLst>
        </c:ser>
        <c:ser>
          <c:idx val="3"/>
          <c:order val="3"/>
          <c:tx>
            <c:strRef>
              <c:f>'[forest plot SN - 8-1-2019.xlsx]Neighborhood SC (2)'!$E$1</c:f>
              <c:strCache>
                <c:ptCount val="1"/>
                <c:pt idx="0">
                  <c:v>Age ≥ 55; Males 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plus"/>
            <c:size val="18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dLbls>
            <c:dLbl>
              <c:idx val="0"/>
              <c:tx>
                <c:rich>
                  <a:bodyPr/>
                  <a:lstStyle/>
                  <a:p>
                    <a:r>
                      <a:rPr lang="it-IT" dirty="0"/>
                      <a:t>B = -1.43</a:t>
                    </a:r>
                    <a:r>
                      <a:rPr lang="it-IT" baseline="0" dirty="0"/>
                      <a:t> (95% CI -6.92, 4.06)</a:t>
                    </a:r>
                    <a:endParaRPr lang="it-IT" dirty="0"/>
                  </a:p>
                </c:rich>
              </c:tx>
              <c:dLblPos val="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6-C578-4694-BAED-F90E891C8736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t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Dir val="x"/>
            <c:errBarType val="both"/>
            <c:errValType val="cust"/>
            <c:noEndCap val="0"/>
            <c:plus>
              <c:numRef>
                <c:f>'[forest plot SN - 8-1-2019.xlsx]Neighborhood SC (2)'!$E$7</c:f>
                <c:numCache>
                  <c:formatCode>General</c:formatCode>
                  <c:ptCount val="1"/>
                  <c:pt idx="0">
                    <c:v>5.5</c:v>
                  </c:pt>
                </c:numCache>
              </c:numRef>
            </c:plus>
            <c:minus>
              <c:numRef>
                <c:f>'[forest plot SN - 8-1-2019.xlsx]Neighborhood SC (2)'!$E$7</c:f>
                <c:numCache>
                  <c:formatCode>General</c:formatCode>
                  <c:ptCount val="1"/>
                  <c:pt idx="0">
                    <c:v>5.5</c:v>
                  </c:pt>
                </c:numCache>
              </c:numRef>
            </c:minus>
            <c:spPr>
              <a:noFill/>
              <a:ln w="25400" cap="rnd" cmpd="sng" algn="ctr">
                <a:solidFill>
                  <a:schemeClr val="accent4"/>
                </a:solidFill>
                <a:prstDash val="solid"/>
                <a:round/>
                <a:headEnd type="oval" w="lg" len="lg"/>
                <a:tailEnd type="oval" w="lg" len="lg"/>
              </a:ln>
              <a:effectLst/>
            </c:spPr>
          </c:errBars>
          <c:xVal>
            <c:numRef>
              <c:f>'[forest plot SN - 8-1-2019.xlsx]Neighborhood SC (2)'!$E$2</c:f>
              <c:numCache>
                <c:formatCode>General</c:formatCode>
                <c:ptCount val="1"/>
                <c:pt idx="0">
                  <c:v>-1.43</c:v>
                </c:pt>
              </c:numCache>
            </c:numRef>
          </c:xVal>
          <c:yVal>
            <c:numLit>
              <c:formatCode>General</c:formatCode>
              <c:ptCount val="1"/>
              <c:pt idx="0">
                <c:v>1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07-C578-4694-BAED-F90E891C873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27382415"/>
        <c:axId val="1933735487"/>
      </c:scatterChart>
      <c:valAx>
        <c:axId val="1727382415"/>
        <c:scaling>
          <c:orientation val="minMax"/>
          <c:max val="12"/>
          <c:min val="-1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 algn="l">
                  <a:defRPr sz="16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 dirty="0"/>
                  <a:t>Supplemental</a:t>
                </a:r>
                <a:r>
                  <a:rPr lang="en-US" b="1" baseline="0" dirty="0"/>
                  <a:t> Figure 3. </a:t>
                </a:r>
                <a:r>
                  <a:rPr lang="en-US" dirty="0"/>
                  <a:t>Associations between neighborhood social cohesion and depressive symptoms score, adjusting for all individual, health-related, psychosocial, and environmental factors, stratified by age and sex.  </a:t>
                </a:r>
              </a:p>
            </c:rich>
          </c:tx>
          <c:layout>
            <c:manualLayout>
              <c:xMode val="edge"/>
              <c:yMode val="edge"/>
              <c:x val="0.11958374475385541"/>
              <c:y val="0.8183765529308836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 algn="l">
                <a:defRPr sz="16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33735487"/>
        <c:crosses val="autoZero"/>
        <c:crossBetween val="midCat"/>
        <c:majorUnit val="2"/>
      </c:valAx>
      <c:valAx>
        <c:axId val="1933735487"/>
        <c:scaling>
          <c:orientation val="minMax"/>
        </c:scaling>
        <c:delete val="1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1727382415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3.6077103190235736E-2"/>
          <c:y val="0.70976220721901884"/>
          <c:w val="0.94408944324784316"/>
          <c:h val="0.1103232887635874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600"/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45812</cdr:x>
      <cdr:y>0.08968</cdr:y>
    </cdr:from>
    <cdr:to>
      <cdr:x>0.45939</cdr:x>
      <cdr:y>0.67127</cdr:y>
    </cdr:to>
    <cdr:cxnSp macro="">
      <cdr:nvCxnSpPr>
        <cdr:cNvPr id="3" name="Straight Connector 2">
          <a:extLst xmlns:a="http://schemas.openxmlformats.org/drawingml/2006/main">
            <a:ext uri="{FF2B5EF4-FFF2-40B4-BE49-F238E27FC236}">
              <a16:creationId xmlns:a16="http://schemas.microsoft.com/office/drawing/2014/main" id="{B3AF95C2-AA59-40F1-A810-22CF505E8461}"/>
            </a:ext>
          </a:extLst>
        </cdr:cNvPr>
        <cdr:cNvCxnSpPr/>
      </cdr:nvCxnSpPr>
      <cdr:spPr>
        <a:xfrm xmlns:a="http://schemas.openxmlformats.org/drawingml/2006/main" flipH="1" flipV="1">
          <a:off x="2149078" y="316706"/>
          <a:ext cx="5954" cy="2053830"/>
        </a:xfrm>
        <a:prstGeom xmlns:a="http://schemas.openxmlformats.org/drawingml/2006/main" prst="line">
          <a:avLst/>
        </a:prstGeom>
        <a:ln xmlns:a="http://schemas.openxmlformats.org/drawingml/2006/main" w="9525" cap="flat" cmpd="sng" algn="ctr">
          <a:solidFill>
            <a:schemeClr val="accent3"/>
          </a:solidFill>
          <a:prstDash val="dash"/>
          <a:round/>
          <a:headEnd type="none" w="med" len="med"/>
          <a:tailEnd type="none" w="med" len="med"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tx1"/>
        </a:fontRef>
      </cdr:style>
    </cdr:cxn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DE10B1-D4D5-406E-85BD-DEE725E3CD6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C15B14F-E000-480C-AE35-95485DE2193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1FBEAAA-E780-40E3-BC3C-A20DAA4C82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51116-838D-4102-8D8E-8F0EE3724FEE}" type="datetimeFigureOut">
              <a:rPr lang="en-US" smtClean="0"/>
              <a:t>3/1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41DFFA-9EF0-48B0-B0C3-BF11CFCD8B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35B95C-AB72-4FFD-88D3-B4FD4F3656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0C01E-388C-4EF3-A5F4-D2CD3D367B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6618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C35F62-791C-4842-8820-17D4885344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BB65CC2-674C-4633-8358-09037696859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FCE7D5-30CB-4534-99DC-93ECDDD818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51116-838D-4102-8D8E-8F0EE3724FEE}" type="datetimeFigureOut">
              <a:rPr lang="en-US" smtClean="0"/>
              <a:t>3/1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35D7EE6-5CD0-4261-80AE-295341DB05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A65E1D-5169-4689-999B-2BA9821E16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0C01E-388C-4EF3-A5F4-D2CD3D367B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96571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B45D36D-74BA-41D9-9EC6-2934D1F9830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5985E4D-3226-4259-8DFB-178ACD05CBA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821B97-22EA-496F-82D9-A2730AD7EC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51116-838D-4102-8D8E-8F0EE3724FEE}" type="datetimeFigureOut">
              <a:rPr lang="en-US" smtClean="0"/>
              <a:t>3/1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678B46-0CF9-4672-9FEB-7DB5B611AC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F7027B0-4C22-4507-8B29-D0B6DBBE1C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0C01E-388C-4EF3-A5F4-D2CD3D367B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1865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266599-9E9E-4079-8DB6-2F8B9EAD34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80046BC-6DCF-4348-9FF5-3B3C9E3A148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AB556EF-A64A-41B1-B22E-436B4AE98B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51116-838D-4102-8D8E-8F0EE3724FEE}" type="datetimeFigureOut">
              <a:rPr lang="en-US" smtClean="0"/>
              <a:t>3/1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5B2865-BFCB-48FA-B695-3D2279601C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9544E3-26AF-4170-9585-0A46248ED8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0C01E-388C-4EF3-A5F4-D2CD3D367B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10190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2AD13F-61C4-41B8-A43C-B008AC789F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BCAFA6F-34BE-4002-91F0-0AAD028193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7B94BDC-6096-4D27-9A15-CE5B260B1F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51116-838D-4102-8D8E-8F0EE3724FEE}" type="datetimeFigureOut">
              <a:rPr lang="en-US" smtClean="0"/>
              <a:t>3/1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47C75FB-F63B-40D8-B3D2-4C21DBC318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5913F4D-7687-4593-9E26-05DC61C513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0C01E-388C-4EF3-A5F4-D2CD3D367B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64176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E8DBB2-A3C9-4057-9A2F-BCB96E3E9F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5EE0AFD-B803-41A8-B245-29623A19A51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C44FC4E-303A-4308-AB89-F4BD07FB10E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F3C0102-189D-4744-ADE5-6213E5C33A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51116-838D-4102-8D8E-8F0EE3724FEE}" type="datetimeFigureOut">
              <a:rPr lang="en-US" smtClean="0"/>
              <a:t>3/12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BFECBB8-8EB8-4F26-9B7C-2C1C183A0E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093D739-489E-4EFA-AE7C-5C641E25E8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0C01E-388C-4EF3-A5F4-D2CD3D367B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23210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79E290-CE8D-4DC0-AEC0-3075D01CE8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43842F0-8E0E-42DC-B354-A518558837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471EA38-D14C-4683-8281-AE806E9D638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9DAF1FD-5970-4182-BD7B-E8B2D11339D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097762E-9804-4EB7-9179-73E40FA07D2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54E54E8-F24C-4898-AD35-79C879701F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51116-838D-4102-8D8E-8F0EE3724FEE}" type="datetimeFigureOut">
              <a:rPr lang="en-US" smtClean="0"/>
              <a:t>3/12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6BBC52F-451A-43E4-A382-4250728251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B299CDD-250A-48B8-A67C-F0B5A2322D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0C01E-388C-4EF3-A5F4-D2CD3D367B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12702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EA30F3-35A6-4C22-B88C-8A88820034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FCC334E-8C33-4511-A5C2-01F479A670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51116-838D-4102-8D8E-8F0EE3724FEE}" type="datetimeFigureOut">
              <a:rPr lang="en-US" smtClean="0"/>
              <a:t>3/12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EC26A45-41E3-4ED6-9D15-E65736CD4E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BC12669-2179-49E4-AC7B-94D9BF1978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0C01E-388C-4EF3-A5F4-D2CD3D367B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94007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76E2119-CAF4-4FF8-AA5C-58CA2F0D22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51116-838D-4102-8D8E-8F0EE3724FEE}" type="datetimeFigureOut">
              <a:rPr lang="en-US" smtClean="0"/>
              <a:t>3/12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9C93D29-87B7-46D8-950D-C950CCA431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8FB3ADE-3229-4A8B-8337-28EF64C07A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0C01E-388C-4EF3-A5F4-D2CD3D367B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72879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C672C5-FA29-4899-979F-1F8386A1FE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579CCE9-B663-446F-8DF7-44D29D2DEB3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CAF67F6-2661-4207-9789-4901B424883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4362FCF-D717-4BF3-A356-54DD3B703F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51116-838D-4102-8D8E-8F0EE3724FEE}" type="datetimeFigureOut">
              <a:rPr lang="en-US" smtClean="0"/>
              <a:t>3/12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3DFC386-FFE8-423B-9440-754F57EA45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4431FFB-D131-466A-A3BF-7B767D0BF0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0C01E-388C-4EF3-A5F4-D2CD3D367B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91119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817A4C-7B1F-4AA5-BCD6-02D5CF7DCC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F743170-6D04-416F-80FA-FFADE806274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E160387-1A93-48A7-81AB-396B927487F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7F2EF69-2237-44AD-970C-E73352374F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51116-838D-4102-8D8E-8F0EE3724FEE}" type="datetimeFigureOut">
              <a:rPr lang="en-US" smtClean="0"/>
              <a:t>3/12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3640E67-7851-4A33-96C4-0EEA0D1C3E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22BAFE1-012A-440E-B298-63D4DCAEA6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0C01E-388C-4EF3-A5F4-D2CD3D367B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51493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B4A884B-D678-4E24-AC88-416FF21A35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BFE7576-2F0B-41A0-9AE2-102F835FA6C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CF3D02-7EA8-441C-912F-29B0FA44809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051116-838D-4102-8D8E-8F0EE3724FEE}" type="datetimeFigureOut">
              <a:rPr lang="en-US" smtClean="0"/>
              <a:t>3/1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722FB4-9E5A-47DD-B302-DC6B2ED0D37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D74597-31FE-4BC8-B32C-670A80F1CEE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30C01E-388C-4EF3-A5F4-D2CD3D367B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75483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E430BE60-1888-4C87-BAA3-70AF3CF52B8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0449941"/>
              </p:ext>
            </p:extLst>
          </p:nvPr>
        </p:nvGraphicFramePr>
        <p:xfrm>
          <a:off x="1322364" y="260059"/>
          <a:ext cx="9754058" cy="663149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7829409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81</TotalTime>
  <Words>90</Words>
  <Application>Microsoft Office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ngerman, Steven (NIH/CC/OD) [F]</dc:creator>
  <cp:lastModifiedBy>Tamura, Kosuke (NIH/NHLBI) [C]</cp:lastModifiedBy>
  <cp:revision>38</cp:revision>
  <dcterms:created xsi:type="dcterms:W3CDTF">2019-06-02T19:52:39Z</dcterms:created>
  <dcterms:modified xsi:type="dcterms:W3CDTF">2020-03-12T16:13:58Z</dcterms:modified>
</cp:coreProperties>
</file>